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1" r:id="rId3"/>
    <p:sldId id="257" r:id="rId4"/>
    <p:sldId id="259" r:id="rId5"/>
    <p:sldId id="25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5052"/>
    <p:restoredTop sz="94646"/>
  </p:normalViewPr>
  <p:slideViewPr>
    <p:cSldViewPr snapToGrid="0" snapToObjects="1">
      <p:cViewPr varScale="1">
        <p:scale>
          <a:sx n="107" d="100"/>
          <a:sy n="107" d="100"/>
        </p:scale>
        <p:origin x="192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9C1554-26D0-2149-85D2-F3A42EA370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87C47F-4636-8448-84FB-4DB5E168A6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1940D7-54FF-E743-9599-F83EA6613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24ACD8-9906-D044-9296-79A8393E7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471FAD-2E65-844D-9F95-717C58C0D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140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74B72-E2F6-384B-8983-563E0E28A7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7E58A8-C8F2-3640-A879-7B8412B3B2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428FF1-CBFB-3041-AAC2-E3FBB24A3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5186AD-4800-594A-BD81-10741A511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15420F-4DFE-EF49-A954-49884E8CC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600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42C2DD-DFB4-2C4E-9054-EF43011A5A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61ADBD-4D05-1D46-B4D7-EF369E2F28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C8F61A-507D-B240-ACAE-E576D866D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32F20E-95EC-BB42-BEBA-FB86BDDF9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90A09B-F7DD-8343-AD6B-EB222465D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736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9DEDAD-5378-BF4F-919C-A40521E7C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05CDD0-E3E8-1E4B-9FEE-947D485E65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B97BE8-C12A-104E-A4BB-F533E3328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5B57B6-EAB5-4C44-BA7F-A3A86D916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BDEF55-F3D9-7F45-B1C1-059C92D91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266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C53D97-0C50-9C4E-BF7A-EF4E89B8C1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B9C9C3-7FD1-5A40-837E-3E88548F02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951E99-F1D3-E24E-9F55-8605BE596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5858F8-2DDF-564A-9234-E80AB7108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391CB4-2491-3E40-9553-6EF2A3249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046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95C641-326A-904C-B235-52314FE259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2AA5FB-1DCD-D94B-BDE0-42DC8C7024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119647-A124-464B-B163-1DF0A15551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69B007-3DCE-BF4D-B141-880DBBECF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2E2788-0F4C-2740-BC1B-A256921D9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22E356-891A-BB47-B4FA-558B7059C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980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E9C2D5-A496-A64C-A861-6391ABBE6E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1BB75C-9C34-A343-990D-7B2C9C3BD8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39B83A-82F4-234E-A53F-F201CA38E5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63E3C9-AD1E-B64E-AC25-09990ADD5E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5DAE68-F8BD-9142-BB57-0F541316F5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3E4D70-4E78-EE4F-BA01-6F26928A71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3E79D1-023A-D544-A315-AC04B5235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00CDAAD-055B-7B48-B1F6-2FF09B030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013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FE78F-012F-E94B-9DD2-83B1FB47A9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0DE3C0-8D82-B14A-9934-8981D316F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F13B12-ACB8-454A-A7E5-F0822AB13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5F39710-4265-7549-B1CB-37F07193F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929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60705B-F47E-9142-9946-6D1B2E76A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BF25CA-A548-B646-AA09-FC9B057AB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0384A1-DEEF-2644-AC12-9EF5474BD4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836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580B5-0CD3-D145-8FD3-A14DDF6E7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FF7F2B-67C3-BB4C-88C2-B2C63F8F2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FA4130-0ADF-9240-94D0-E146778457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5C81C1-D4C8-CC4B-AC49-741A2F2D0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A90F36-1F08-E14B-8F84-E9EE75DE0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647374-C364-F441-9AFD-5824BAB10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583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B43D9-3F49-9F4A-8926-8778293D41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6479C6-B995-BB47-A678-C4D4EB9204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F6B9FE-ADF0-8145-ACB5-96DCF8206D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0E1C88-42C7-9B49-861E-F28E7FF21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FBDC77-7B5B-D741-9E9B-1D2EDABF4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8124FD-49AB-5442-8573-7DEF2E249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19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F843AF-0938-154F-9276-7F7156DD10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C69EF1-CF44-5D4C-BA90-BDE970CE20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44D168-6489-2B45-BBB9-3009B4D47B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441E-3474-404B-9DB9-8C7C6C4691BA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B2EF52-6FDB-5F4D-B6B5-9B2A8A9E05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D848C7-CFCD-E843-BAA4-12EC95C964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27F1CA-CEE5-F148-AB37-71B7B4ACF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959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>
            <a:extLst>
              <a:ext uri="{FF2B5EF4-FFF2-40B4-BE49-F238E27FC236}">
                <a16:creationId xmlns:a16="http://schemas.microsoft.com/office/drawing/2014/main" id="{7070BFF5-81E9-E44B-B6EC-DA5BFE951F6F}"/>
              </a:ext>
            </a:extLst>
          </p:cNvPr>
          <p:cNvGrpSpPr/>
          <p:nvPr/>
        </p:nvGrpSpPr>
        <p:grpSpPr>
          <a:xfrm>
            <a:off x="1171416" y="270794"/>
            <a:ext cx="11020584" cy="5401341"/>
            <a:chOff x="712958" y="37240"/>
            <a:chExt cx="11110110" cy="663502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BD04969-F8EF-0645-AFC9-F8A0493C73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6273"/>
            <a:stretch/>
          </p:blipFill>
          <p:spPr>
            <a:xfrm>
              <a:off x="1797260" y="2737385"/>
              <a:ext cx="8961228" cy="2327963"/>
            </a:xfrm>
            <a:prstGeom prst="rect">
              <a:avLst/>
            </a:prstGeom>
          </p:spPr>
        </p:pic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6C656F79-4066-DE4A-94EE-3E9FA06BF1FA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3345731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C1B3D551-731E-0344-BE1F-3B8A4BE3E23C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2985368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67F5B9B2-67D0-3943-86CD-0F058BEDD130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3866634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0469DBE-D4EF-5341-BE7E-6A9050271071}"/>
                </a:ext>
              </a:extLst>
            </p:cNvPr>
            <p:cNvSpPr txBox="1"/>
            <p:nvPr/>
          </p:nvSpPr>
          <p:spPr>
            <a:xfrm>
              <a:off x="748382" y="2773456"/>
              <a:ext cx="385281" cy="3231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49B4DB1-7E7A-3F4F-80A1-DA565E862061}"/>
                </a:ext>
              </a:extLst>
            </p:cNvPr>
            <p:cNvSpPr txBox="1"/>
            <p:nvPr/>
          </p:nvSpPr>
          <p:spPr>
            <a:xfrm>
              <a:off x="748382" y="3114699"/>
              <a:ext cx="385281" cy="3231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1F4D26E-C564-3D49-AB9B-9C39624AEF87}"/>
                </a:ext>
              </a:extLst>
            </p:cNvPr>
            <p:cNvSpPr txBox="1"/>
            <p:nvPr/>
          </p:nvSpPr>
          <p:spPr>
            <a:xfrm>
              <a:off x="728662" y="3608497"/>
              <a:ext cx="420704" cy="323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21264E6-037E-8048-858D-721DB7DC1F07}"/>
                </a:ext>
              </a:extLst>
            </p:cNvPr>
            <p:cNvSpPr txBox="1"/>
            <p:nvPr/>
          </p:nvSpPr>
          <p:spPr>
            <a:xfrm>
              <a:off x="10887075" y="3739783"/>
              <a:ext cx="560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AX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4DB7EA2-0710-9B41-B66D-6C6EABB9CACB}"/>
                </a:ext>
              </a:extLst>
            </p:cNvPr>
            <p:cNvSpPr txBox="1"/>
            <p:nvPr/>
          </p:nvSpPr>
          <p:spPr>
            <a:xfrm>
              <a:off x="3415178" y="37240"/>
              <a:ext cx="654158" cy="4536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A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389E1D8-0EC3-8D4A-98EA-879809AE7245}"/>
                </a:ext>
              </a:extLst>
            </p:cNvPr>
            <p:cNvSpPr txBox="1"/>
            <p:nvPr/>
          </p:nvSpPr>
          <p:spPr>
            <a:xfrm>
              <a:off x="8236187" y="37240"/>
              <a:ext cx="1420374" cy="4536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E-Cig-2.4%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494FB75-0F2B-584D-8D0F-A7924F9621CC}"/>
                </a:ext>
              </a:extLst>
            </p:cNvPr>
            <p:cNvSpPr txBox="1"/>
            <p:nvPr/>
          </p:nvSpPr>
          <p:spPr>
            <a:xfrm>
              <a:off x="5480437" y="37240"/>
              <a:ext cx="1198751" cy="4536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E-Cig-0%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919FE257-38EA-9F44-9BE8-ABA22EAAE4B9}"/>
                </a:ext>
              </a:extLst>
            </p:cNvPr>
            <p:cNvCxnSpPr/>
            <p:nvPr/>
          </p:nvCxnSpPr>
          <p:spPr>
            <a:xfrm>
              <a:off x="2769621" y="452204"/>
              <a:ext cx="1859602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AF452034-FE68-5F4E-B4AA-C000C5A7BD15}"/>
                </a:ext>
              </a:extLst>
            </p:cNvPr>
            <p:cNvCxnSpPr/>
            <p:nvPr/>
          </p:nvCxnSpPr>
          <p:spPr>
            <a:xfrm>
              <a:off x="5239906" y="452204"/>
              <a:ext cx="1859602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0A9DD0FF-6298-AC40-BB5D-275DDCA7100A}"/>
                </a:ext>
              </a:extLst>
            </p:cNvPr>
            <p:cNvCxnSpPr/>
            <p:nvPr/>
          </p:nvCxnSpPr>
          <p:spPr>
            <a:xfrm>
              <a:off x="8016574" y="452204"/>
              <a:ext cx="1859602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7817706-1768-8143-BA0A-3DD1332A699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flipH="1">
              <a:off x="1797260" y="5204023"/>
              <a:ext cx="9089815" cy="1468239"/>
            </a:xfrm>
            <a:prstGeom prst="rect">
              <a:avLst/>
            </a:prstGeom>
          </p:spPr>
        </p:pic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D908CD28-FE1A-E543-A0E5-BFE302CB21B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5955042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F9B9F296-E62C-334A-A1BF-85129622B6D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5594679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81FE0250-7DBB-864F-B9CB-DDF33BDD7029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6475945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55FC61D-C504-8942-87DE-0B61D11AAFBD}"/>
                </a:ext>
              </a:extLst>
            </p:cNvPr>
            <p:cNvSpPr txBox="1"/>
            <p:nvPr/>
          </p:nvSpPr>
          <p:spPr>
            <a:xfrm>
              <a:off x="748382" y="5724010"/>
              <a:ext cx="385281" cy="3231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46CBAFC-19AE-004B-865C-290B349CE852}"/>
                </a:ext>
              </a:extLst>
            </p:cNvPr>
            <p:cNvSpPr txBox="1"/>
            <p:nvPr/>
          </p:nvSpPr>
          <p:spPr>
            <a:xfrm>
              <a:off x="712958" y="6261570"/>
              <a:ext cx="420704" cy="323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6DE7583-FFA0-4446-BBA3-5BAD2FBAF7A9}"/>
                </a:ext>
              </a:extLst>
            </p:cNvPr>
            <p:cNvSpPr txBox="1"/>
            <p:nvPr/>
          </p:nvSpPr>
          <p:spPr>
            <a:xfrm>
              <a:off x="748382" y="5345571"/>
              <a:ext cx="385281" cy="3231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F0A191F-5F44-574C-812C-C8A8BC0675F9}"/>
                </a:ext>
              </a:extLst>
            </p:cNvPr>
            <p:cNvSpPr txBox="1"/>
            <p:nvPr/>
          </p:nvSpPr>
          <p:spPr>
            <a:xfrm>
              <a:off x="10927476" y="5674691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C3870BDB-AD02-E343-AB6A-59BDC0D50E9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97260" y="623942"/>
              <a:ext cx="8961228" cy="2076162"/>
            </a:xfrm>
            <a:prstGeom prst="rect">
              <a:avLst/>
            </a:prstGeom>
          </p:spPr>
        </p:pic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1530FEBB-D341-FF49-A2ED-0C84C8CA5C48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1059587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60BFAC56-D7B3-1041-AF75-8A9D1EA0F35C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1580492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F74DFC5-03B0-4E46-9DB2-B147EB07E548}"/>
                </a:ext>
              </a:extLst>
            </p:cNvPr>
            <p:cNvSpPr txBox="1"/>
            <p:nvPr/>
          </p:nvSpPr>
          <p:spPr>
            <a:xfrm>
              <a:off x="748382" y="828557"/>
              <a:ext cx="385281" cy="3231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636D874-4131-2D42-98D2-C05680F4A742}"/>
                </a:ext>
              </a:extLst>
            </p:cNvPr>
            <p:cNvSpPr txBox="1"/>
            <p:nvPr/>
          </p:nvSpPr>
          <p:spPr>
            <a:xfrm>
              <a:off x="712958" y="1366117"/>
              <a:ext cx="420704" cy="323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A2FC0AD9-0C3F-EC41-BEFD-E303E310FD1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646" y="2143761"/>
              <a:ext cx="5390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B81C033-2292-CF42-AC15-CDB261E49E68}"/>
                </a:ext>
              </a:extLst>
            </p:cNvPr>
            <p:cNvSpPr txBox="1"/>
            <p:nvPr/>
          </p:nvSpPr>
          <p:spPr>
            <a:xfrm>
              <a:off x="714958" y="1912729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3F0DBF5-012F-8545-912A-9B65548552C6}"/>
                </a:ext>
              </a:extLst>
            </p:cNvPr>
            <p:cNvSpPr txBox="1"/>
            <p:nvPr/>
          </p:nvSpPr>
          <p:spPr>
            <a:xfrm>
              <a:off x="10681730" y="1785660"/>
              <a:ext cx="114133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leaved</a:t>
              </a:r>
            </a:p>
            <a:p>
              <a:r>
                <a:rPr lang="en-US" dirty="0"/>
                <a:t> caspase 3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A1717393-0564-4F45-A6C6-CA31F62D85CB}"/>
              </a:ext>
            </a:extLst>
          </p:cNvPr>
          <p:cNvSpPr txBox="1"/>
          <p:nvPr/>
        </p:nvSpPr>
        <p:spPr>
          <a:xfrm>
            <a:off x="312603" y="6218374"/>
            <a:ext cx="2762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.3E. Uncropped data</a:t>
            </a:r>
          </a:p>
        </p:txBody>
      </p:sp>
    </p:spTree>
    <p:extLst>
      <p:ext uri="{BB962C8B-B14F-4D97-AF65-F5344CB8AC3E}">
        <p14:creationId xmlns:p14="http://schemas.microsoft.com/office/powerpoint/2010/main" val="12027788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>
            <a:extLst>
              <a:ext uri="{FF2B5EF4-FFF2-40B4-BE49-F238E27FC236}">
                <a16:creationId xmlns:a16="http://schemas.microsoft.com/office/drawing/2014/main" id="{5DE3EA89-1320-E74B-B52C-398BADD041C6}"/>
              </a:ext>
            </a:extLst>
          </p:cNvPr>
          <p:cNvGrpSpPr/>
          <p:nvPr/>
        </p:nvGrpSpPr>
        <p:grpSpPr>
          <a:xfrm>
            <a:off x="624840" y="744312"/>
            <a:ext cx="10698480" cy="5686968"/>
            <a:chOff x="125992" y="-4330"/>
            <a:chExt cx="11609276" cy="664365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BC233F1-1A43-624F-8BA9-6585DCD39F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30000" contrast="59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2057400" y="576580"/>
              <a:ext cx="8656320" cy="37211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4F8379D-AC52-3E40-87A6-5CDC7E71DAE2}"/>
                </a:ext>
              </a:extLst>
            </p:cNvPr>
            <p:cNvSpPr txBox="1"/>
            <p:nvPr/>
          </p:nvSpPr>
          <p:spPr>
            <a:xfrm>
              <a:off x="10713720" y="2575560"/>
              <a:ext cx="7072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HNE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B985247-15DC-E743-80C5-0734F7AF78B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10000" contrast="36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2057400" y="4745202"/>
              <a:ext cx="8614410" cy="1305319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8B6AD37-E5DC-3649-B316-6D0B76DA38E9}"/>
                </a:ext>
              </a:extLst>
            </p:cNvPr>
            <p:cNvSpPr txBox="1"/>
            <p:nvPr/>
          </p:nvSpPr>
          <p:spPr>
            <a:xfrm>
              <a:off x="10866119" y="5410200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2254950-8765-704A-8214-6B68E8493676}"/>
                </a:ext>
              </a:extLst>
            </p:cNvPr>
            <p:cNvSpPr txBox="1"/>
            <p:nvPr/>
          </p:nvSpPr>
          <p:spPr>
            <a:xfrm>
              <a:off x="2901111" y="-4330"/>
              <a:ext cx="733902" cy="431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A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0A227A3-E8E9-9048-9957-FFAA9F39C6D0}"/>
                </a:ext>
              </a:extLst>
            </p:cNvPr>
            <p:cNvSpPr txBox="1"/>
            <p:nvPr/>
          </p:nvSpPr>
          <p:spPr>
            <a:xfrm>
              <a:off x="8512199" y="-4330"/>
              <a:ext cx="1537122" cy="431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E-Cig-2.4%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7516C0F-37F8-904B-9C3E-51F9B81A1570}"/>
                </a:ext>
              </a:extLst>
            </p:cNvPr>
            <p:cNvSpPr txBox="1"/>
            <p:nvPr/>
          </p:nvSpPr>
          <p:spPr>
            <a:xfrm>
              <a:off x="5682928" y="-4330"/>
              <a:ext cx="1372044" cy="431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E-Cig-0%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5C81D6B5-B16E-6A42-8E44-9870B736FDB5}"/>
                </a:ext>
              </a:extLst>
            </p:cNvPr>
            <p:cNvCxnSpPr/>
            <p:nvPr/>
          </p:nvCxnSpPr>
          <p:spPr>
            <a:xfrm>
              <a:off x="2419215" y="424858"/>
              <a:ext cx="1967116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84EFE94B-E008-0849-9275-184C574C6DD2}"/>
                </a:ext>
              </a:extLst>
            </p:cNvPr>
            <p:cNvCxnSpPr/>
            <p:nvPr/>
          </p:nvCxnSpPr>
          <p:spPr>
            <a:xfrm>
              <a:off x="5489478" y="393700"/>
              <a:ext cx="1967116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59948C14-3433-C84D-B8BD-3A3F81A6C69F}"/>
                </a:ext>
              </a:extLst>
            </p:cNvPr>
            <p:cNvCxnSpPr/>
            <p:nvPr/>
          </p:nvCxnSpPr>
          <p:spPr>
            <a:xfrm>
              <a:off x="8297201" y="365778"/>
              <a:ext cx="1967116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1AEBA024-AA34-F241-B8FB-842BED2E9B07}"/>
                </a:ext>
              </a:extLst>
            </p:cNvPr>
            <p:cNvCxnSpPr>
              <a:cxnSpLocks/>
            </p:cNvCxnSpPr>
            <p:nvPr/>
          </p:nvCxnSpPr>
          <p:spPr>
            <a:xfrm>
              <a:off x="1522717" y="5633277"/>
              <a:ext cx="534683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A42B1EF4-1E4B-E640-BB4F-B4C25CF7F858}"/>
                </a:ext>
              </a:extLst>
            </p:cNvPr>
            <p:cNvCxnSpPr>
              <a:cxnSpLocks/>
            </p:cNvCxnSpPr>
            <p:nvPr/>
          </p:nvCxnSpPr>
          <p:spPr>
            <a:xfrm>
              <a:off x="1522717" y="5339918"/>
              <a:ext cx="534683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4696FE4-9BD5-0244-B838-520DBDBE071C}"/>
                </a:ext>
              </a:extLst>
            </p:cNvPr>
            <p:cNvSpPr txBox="1"/>
            <p:nvPr/>
          </p:nvSpPr>
          <p:spPr>
            <a:xfrm>
              <a:off x="1144525" y="5405470"/>
              <a:ext cx="382176" cy="2630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6037612-ECBF-6849-BEE3-2A9E34F591C6}"/>
                </a:ext>
              </a:extLst>
            </p:cNvPr>
            <p:cNvSpPr txBox="1"/>
            <p:nvPr/>
          </p:nvSpPr>
          <p:spPr>
            <a:xfrm>
              <a:off x="1124963" y="5111269"/>
              <a:ext cx="382176" cy="2630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33CBAF28-E19D-0149-BDB0-397A29F3D9FC}"/>
                </a:ext>
              </a:extLst>
            </p:cNvPr>
            <p:cNvCxnSpPr>
              <a:cxnSpLocks/>
            </p:cNvCxnSpPr>
            <p:nvPr/>
          </p:nvCxnSpPr>
          <p:spPr>
            <a:xfrm>
              <a:off x="1410351" y="2376239"/>
              <a:ext cx="5369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57DED554-DB34-A545-9E1C-F2C5D139A9F4}"/>
                </a:ext>
              </a:extLst>
            </p:cNvPr>
            <p:cNvCxnSpPr>
              <a:cxnSpLocks/>
            </p:cNvCxnSpPr>
            <p:nvPr/>
          </p:nvCxnSpPr>
          <p:spPr>
            <a:xfrm>
              <a:off x="1410351" y="1990254"/>
              <a:ext cx="5369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097FAD9D-21B0-0244-AEF1-70808EBA6EB1}"/>
                </a:ext>
              </a:extLst>
            </p:cNvPr>
            <p:cNvCxnSpPr>
              <a:cxnSpLocks/>
            </p:cNvCxnSpPr>
            <p:nvPr/>
          </p:nvCxnSpPr>
          <p:spPr>
            <a:xfrm>
              <a:off x="1410351" y="2934178"/>
              <a:ext cx="53692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AC4BAE8-98E4-B244-A895-70CC5FAFC81D}"/>
                </a:ext>
              </a:extLst>
            </p:cNvPr>
            <p:cNvSpPr txBox="1"/>
            <p:nvPr/>
          </p:nvSpPr>
          <p:spPr>
            <a:xfrm>
              <a:off x="983265" y="1760877"/>
              <a:ext cx="711246" cy="431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7F323B3-1872-1945-A4EB-1D82FB88FE5F}"/>
                </a:ext>
              </a:extLst>
            </p:cNvPr>
            <p:cNvSpPr txBox="1"/>
            <p:nvPr/>
          </p:nvSpPr>
          <p:spPr>
            <a:xfrm>
              <a:off x="957493" y="2728944"/>
              <a:ext cx="485388" cy="431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A38205C-6B18-1E4C-9417-47FF70B484B3}"/>
                </a:ext>
              </a:extLst>
            </p:cNvPr>
            <p:cNvSpPr txBox="1"/>
            <p:nvPr/>
          </p:nvSpPr>
          <p:spPr>
            <a:xfrm>
              <a:off x="969616" y="2181389"/>
              <a:ext cx="383780" cy="3461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64F6083-04CF-3E4A-B0EE-025F94968F43}"/>
                </a:ext>
              </a:extLst>
            </p:cNvPr>
            <p:cNvSpPr txBox="1"/>
            <p:nvPr/>
          </p:nvSpPr>
          <p:spPr>
            <a:xfrm>
              <a:off x="125992" y="6269993"/>
              <a:ext cx="27751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.4B. Uncropped dat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343627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451B1E0F-7E8C-1C44-90CA-9A09C1691BE5}"/>
              </a:ext>
            </a:extLst>
          </p:cNvPr>
          <p:cNvGrpSpPr/>
          <p:nvPr/>
        </p:nvGrpSpPr>
        <p:grpSpPr>
          <a:xfrm>
            <a:off x="1221863" y="296576"/>
            <a:ext cx="9336006" cy="4993990"/>
            <a:chOff x="-198731" y="268018"/>
            <a:chExt cx="12287021" cy="586551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14EF37D-3C7E-F64C-A13C-34B2996AF7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2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1063441" y="880512"/>
              <a:ext cx="9872662" cy="22733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465815E-6C68-0942-95B3-96CECE7511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153" r="2057"/>
            <a:stretch/>
          </p:blipFill>
          <p:spPr>
            <a:xfrm flipH="1">
              <a:off x="1063441" y="3364929"/>
              <a:ext cx="9872662" cy="276860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5AEAD0C-D257-F843-83BF-180CDA31C808}"/>
                </a:ext>
              </a:extLst>
            </p:cNvPr>
            <p:cNvSpPr txBox="1"/>
            <p:nvPr/>
          </p:nvSpPr>
          <p:spPr>
            <a:xfrm>
              <a:off x="11001375" y="1871663"/>
              <a:ext cx="1086915" cy="43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CC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54CE704-C197-0646-91E6-8178FEFD5BC7}"/>
                </a:ext>
              </a:extLst>
            </p:cNvPr>
            <p:cNvSpPr txBox="1"/>
            <p:nvPr/>
          </p:nvSpPr>
          <p:spPr>
            <a:xfrm>
              <a:off x="11101388" y="4657725"/>
              <a:ext cx="901262" cy="43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CC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9CF8D5C3-A64E-D142-9B7F-F92F9EDCC8A3}"/>
                </a:ext>
              </a:extLst>
            </p:cNvPr>
            <p:cNvCxnSpPr>
              <a:cxnSpLocks/>
            </p:cNvCxnSpPr>
            <p:nvPr/>
          </p:nvCxnSpPr>
          <p:spPr>
            <a:xfrm>
              <a:off x="477654" y="2238852"/>
              <a:ext cx="58578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100B235C-7C69-9647-BB63-6C85B630AD14}"/>
                </a:ext>
              </a:extLst>
            </p:cNvPr>
            <p:cNvCxnSpPr>
              <a:cxnSpLocks/>
            </p:cNvCxnSpPr>
            <p:nvPr/>
          </p:nvCxnSpPr>
          <p:spPr>
            <a:xfrm>
              <a:off x="477654" y="2536270"/>
              <a:ext cx="58578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434F167-D41A-4145-B5C4-FF7B12995B54}"/>
                </a:ext>
              </a:extLst>
            </p:cNvPr>
            <p:cNvSpPr txBox="1"/>
            <p:nvPr/>
          </p:nvSpPr>
          <p:spPr>
            <a:xfrm>
              <a:off x="-198731" y="2017162"/>
              <a:ext cx="749364" cy="43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6587CB8-01BA-8F4E-BBCA-A3E9AED29D20}"/>
                </a:ext>
              </a:extLst>
            </p:cNvPr>
            <p:cNvSpPr txBox="1"/>
            <p:nvPr/>
          </p:nvSpPr>
          <p:spPr>
            <a:xfrm>
              <a:off x="-198731" y="2351604"/>
              <a:ext cx="749364" cy="43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BF9FADBB-F4EC-224A-8483-721EF03CD867}"/>
                </a:ext>
              </a:extLst>
            </p:cNvPr>
            <p:cNvCxnSpPr>
              <a:cxnSpLocks/>
            </p:cNvCxnSpPr>
            <p:nvPr/>
          </p:nvCxnSpPr>
          <p:spPr>
            <a:xfrm>
              <a:off x="489985" y="4729639"/>
              <a:ext cx="58578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590A63DD-7982-5948-BE0F-8FEEB7ED7C46}"/>
                </a:ext>
              </a:extLst>
            </p:cNvPr>
            <p:cNvCxnSpPr>
              <a:cxnSpLocks/>
            </p:cNvCxnSpPr>
            <p:nvPr/>
          </p:nvCxnSpPr>
          <p:spPr>
            <a:xfrm>
              <a:off x="489985" y="5027057"/>
              <a:ext cx="585787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1FE4D45-FAD4-D946-94D3-E659CB63CABD}"/>
                </a:ext>
              </a:extLst>
            </p:cNvPr>
            <p:cNvSpPr txBox="1"/>
            <p:nvPr/>
          </p:nvSpPr>
          <p:spPr>
            <a:xfrm>
              <a:off x="-186401" y="4507949"/>
              <a:ext cx="749364" cy="43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20606DF-4CCD-0842-8E0F-DE562A067A96}"/>
                </a:ext>
              </a:extLst>
            </p:cNvPr>
            <p:cNvSpPr txBox="1"/>
            <p:nvPr/>
          </p:nvSpPr>
          <p:spPr>
            <a:xfrm>
              <a:off x="-186401" y="4842391"/>
              <a:ext cx="749364" cy="43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265FE1DF-97F4-2F47-A441-375D8F066F08}"/>
                </a:ext>
              </a:extLst>
            </p:cNvPr>
            <p:cNvGrpSpPr/>
            <p:nvPr/>
          </p:nvGrpSpPr>
          <p:grpSpPr>
            <a:xfrm>
              <a:off x="1328738" y="268018"/>
              <a:ext cx="9015412" cy="446498"/>
              <a:chOff x="1871663" y="665423"/>
              <a:chExt cx="6866627" cy="446498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C2FA12E-4AFA-D24D-BCB9-CDA7047B962C}"/>
                  </a:ext>
                </a:extLst>
              </p:cNvPr>
              <p:cNvSpPr txBox="1"/>
              <p:nvPr/>
            </p:nvSpPr>
            <p:spPr>
              <a:xfrm>
                <a:off x="2575965" y="678136"/>
                <a:ext cx="981621" cy="4337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AL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B733ECF9-757C-6F4E-BB4C-9D17DB926A0D}"/>
                  </a:ext>
                </a:extLst>
              </p:cNvPr>
              <p:cNvSpPr txBox="1"/>
              <p:nvPr/>
            </p:nvSpPr>
            <p:spPr>
              <a:xfrm>
                <a:off x="7044422" y="665423"/>
                <a:ext cx="1393467" cy="4337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-Cig-2.4%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81F870B0-8655-F141-A9AB-295D330AF404}"/>
                  </a:ext>
                </a:extLst>
              </p:cNvPr>
              <p:cNvSpPr txBox="1"/>
              <p:nvPr/>
            </p:nvSpPr>
            <p:spPr>
              <a:xfrm>
                <a:off x="4782753" y="665423"/>
                <a:ext cx="1200645" cy="4337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-Cig-0%</a:t>
                </a:r>
              </a:p>
            </p:txBody>
          </p: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F0F91037-DC97-A847-A5D7-53A16C458706}"/>
                  </a:ext>
                </a:extLst>
              </p:cNvPr>
              <p:cNvCxnSpPr/>
              <p:nvPr/>
            </p:nvCxnSpPr>
            <p:spPr>
              <a:xfrm>
                <a:off x="1871663" y="1057275"/>
                <a:ext cx="2028825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984481B1-3172-3B4E-B422-0F73B2A75684}"/>
                  </a:ext>
                </a:extLst>
              </p:cNvPr>
              <p:cNvCxnSpPr/>
              <p:nvPr/>
            </p:nvCxnSpPr>
            <p:spPr>
              <a:xfrm>
                <a:off x="4368664" y="1066800"/>
                <a:ext cx="2028825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40F23602-AFF9-DD4D-B74F-92EF243F219E}"/>
                  </a:ext>
                </a:extLst>
              </p:cNvPr>
              <p:cNvCxnSpPr/>
              <p:nvPr/>
            </p:nvCxnSpPr>
            <p:spPr>
              <a:xfrm>
                <a:off x="6709465" y="1057275"/>
                <a:ext cx="2028825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87F506D2-8E92-3844-A832-040261A6AEDD}"/>
              </a:ext>
            </a:extLst>
          </p:cNvPr>
          <p:cNvSpPr txBox="1"/>
          <p:nvPr/>
        </p:nvSpPr>
        <p:spPr>
          <a:xfrm>
            <a:off x="302582" y="6325215"/>
            <a:ext cx="2702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.5A Uncropped data</a:t>
            </a:r>
          </a:p>
        </p:txBody>
      </p:sp>
    </p:spTree>
    <p:extLst>
      <p:ext uri="{BB962C8B-B14F-4D97-AF65-F5344CB8AC3E}">
        <p14:creationId xmlns:p14="http://schemas.microsoft.com/office/powerpoint/2010/main" val="35191205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7F3ED15F-E742-AB47-902F-87235475F834}"/>
              </a:ext>
            </a:extLst>
          </p:cNvPr>
          <p:cNvGrpSpPr/>
          <p:nvPr/>
        </p:nvGrpSpPr>
        <p:grpSpPr>
          <a:xfrm>
            <a:off x="576902" y="566737"/>
            <a:ext cx="10062512" cy="5428365"/>
            <a:chOff x="13022" y="185737"/>
            <a:chExt cx="10062512" cy="5993563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615877C2-54D5-C04D-83A7-6D01BDED3DC6}"/>
                </a:ext>
              </a:extLst>
            </p:cNvPr>
            <p:cNvGrpSpPr/>
            <p:nvPr/>
          </p:nvGrpSpPr>
          <p:grpSpPr>
            <a:xfrm>
              <a:off x="791804" y="185737"/>
              <a:ext cx="9283730" cy="4122635"/>
              <a:chOff x="319109" y="652708"/>
              <a:chExt cx="10128545" cy="4398801"/>
            </a:xfrm>
          </p:grpSpPr>
          <p:cxnSp>
            <p:nvCxnSpPr>
              <p:cNvPr id="5" name="Straight Connector 4">
                <a:extLst>
                  <a:ext uri="{FF2B5EF4-FFF2-40B4-BE49-F238E27FC236}">
                    <a16:creationId xmlns:a16="http://schemas.microsoft.com/office/drawing/2014/main" id="{7B797842-5239-7B41-AF65-218611D049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9951" y="4876208"/>
                <a:ext cx="585787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84ED8F8A-F9D4-824F-8CF0-3DDCF55B91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9951" y="4464367"/>
                <a:ext cx="585787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C0D5603-2F44-FF44-9E11-F1C701410925}"/>
                  </a:ext>
                </a:extLst>
              </p:cNvPr>
              <p:cNvSpPr txBox="1"/>
              <p:nvPr/>
            </p:nvSpPr>
            <p:spPr>
              <a:xfrm>
                <a:off x="319109" y="4199939"/>
                <a:ext cx="485207" cy="4351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236AD886-ED21-D647-8D92-D1E34DE150D0}"/>
                  </a:ext>
                </a:extLst>
              </p:cNvPr>
              <p:cNvSpPr txBox="1"/>
              <p:nvPr/>
            </p:nvSpPr>
            <p:spPr>
              <a:xfrm>
                <a:off x="319109" y="4616406"/>
                <a:ext cx="481290" cy="4351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6B67DEC0-3F72-F147-ABF3-7E2FD6B8CE04}"/>
                  </a:ext>
                </a:extLst>
              </p:cNvPr>
              <p:cNvSpPr txBox="1"/>
              <p:nvPr/>
            </p:nvSpPr>
            <p:spPr>
              <a:xfrm>
                <a:off x="9350760" y="3962934"/>
                <a:ext cx="942993" cy="4351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PK</a:t>
                </a:r>
              </a:p>
            </p:txBody>
          </p:sp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F1DDEAA0-6C0F-0944-85B3-EA9C208776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bright="12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flipH="1">
                <a:off x="1559893" y="1257300"/>
                <a:ext cx="7772400" cy="1724056"/>
              </a:xfrm>
              <a:prstGeom prst="rect">
                <a:avLst/>
              </a:prstGeom>
            </p:spPr>
          </p:pic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7511B0EC-B59A-DB42-A558-564C182BF8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428" y="2820162"/>
                <a:ext cx="585787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C82A230E-261C-B340-AA02-77D3DB1D85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428" y="2493936"/>
                <a:ext cx="585787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D4D79A9-78F6-5448-AEB6-063186CA8FCF}"/>
                  </a:ext>
                </a:extLst>
              </p:cNvPr>
              <p:cNvSpPr txBox="1"/>
              <p:nvPr/>
            </p:nvSpPr>
            <p:spPr>
              <a:xfrm>
                <a:off x="333587" y="2229513"/>
                <a:ext cx="485207" cy="4351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4975CF2-8388-8C42-9D6F-FD8274ED5104}"/>
                  </a:ext>
                </a:extLst>
              </p:cNvPr>
              <p:cNvSpPr txBox="1"/>
              <p:nvPr/>
            </p:nvSpPr>
            <p:spPr>
              <a:xfrm>
                <a:off x="333587" y="2568764"/>
                <a:ext cx="481290" cy="4351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5BF1E2C-30A0-1749-9935-A3103D63F7BF}"/>
                  </a:ext>
                </a:extLst>
              </p:cNvPr>
              <p:cNvSpPr txBox="1"/>
              <p:nvPr/>
            </p:nvSpPr>
            <p:spPr>
              <a:xfrm>
                <a:off x="9350760" y="1934662"/>
                <a:ext cx="1096894" cy="4351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MPK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DC991C71-300A-9347-8D1D-4ADEE76B250C}"/>
                  </a:ext>
                </a:extLst>
              </p:cNvPr>
              <p:cNvGrpSpPr/>
              <p:nvPr/>
            </p:nvGrpSpPr>
            <p:grpSpPr>
              <a:xfrm>
                <a:off x="1871663" y="652708"/>
                <a:ext cx="6866627" cy="460531"/>
                <a:chOff x="1871663" y="652708"/>
                <a:chExt cx="6866627" cy="460531"/>
              </a:xfrm>
            </p:grpSpPr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12177647-B284-9749-8F5B-C51FC1E61137}"/>
                    </a:ext>
                  </a:extLst>
                </p:cNvPr>
                <p:cNvSpPr txBox="1"/>
                <p:nvPr/>
              </p:nvSpPr>
              <p:spPr>
                <a:xfrm>
                  <a:off x="2575965" y="678136"/>
                  <a:ext cx="981621" cy="4351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AL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2A31E956-EE43-4E46-B0D0-658E008FA654}"/>
                    </a:ext>
                  </a:extLst>
                </p:cNvPr>
                <p:cNvSpPr txBox="1"/>
                <p:nvPr/>
              </p:nvSpPr>
              <p:spPr>
                <a:xfrm>
                  <a:off x="7044422" y="665422"/>
                  <a:ext cx="1516625" cy="4351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-Cig-2.4%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B7918D28-FFA4-7548-91F5-7FAAFEFE9C9F}"/>
                    </a:ext>
                  </a:extLst>
                </p:cNvPr>
                <p:cNvSpPr txBox="1"/>
                <p:nvPr/>
              </p:nvSpPr>
              <p:spPr>
                <a:xfrm>
                  <a:off x="4893504" y="652708"/>
                  <a:ext cx="1306760" cy="4351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-Cig-0%</a:t>
                  </a:r>
                </a:p>
              </p:txBody>
            </p:sp>
            <p:cxnSp>
              <p:nvCxnSpPr>
                <p:cNvPr id="25" name="Straight Connector 24">
                  <a:extLst>
                    <a:ext uri="{FF2B5EF4-FFF2-40B4-BE49-F238E27FC236}">
                      <a16:creationId xmlns:a16="http://schemas.microsoft.com/office/drawing/2014/main" id="{33B8CDF9-8C06-464C-9A21-2C9C1D666033}"/>
                    </a:ext>
                  </a:extLst>
                </p:cNvPr>
                <p:cNvCxnSpPr/>
                <p:nvPr/>
              </p:nvCxnSpPr>
              <p:spPr>
                <a:xfrm>
                  <a:off x="1871663" y="1057275"/>
                  <a:ext cx="2028825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Connector 25">
                  <a:extLst>
                    <a:ext uri="{FF2B5EF4-FFF2-40B4-BE49-F238E27FC236}">
                      <a16:creationId xmlns:a16="http://schemas.microsoft.com/office/drawing/2014/main" id="{005DBDC1-578D-F243-AF91-9BE671D66FC3}"/>
                    </a:ext>
                  </a:extLst>
                </p:cNvPr>
                <p:cNvCxnSpPr/>
                <p:nvPr/>
              </p:nvCxnSpPr>
              <p:spPr>
                <a:xfrm>
                  <a:off x="4368664" y="1066800"/>
                  <a:ext cx="2028825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AFDA3167-B7EA-BA4F-81BD-CA1B7D345983}"/>
                    </a:ext>
                  </a:extLst>
                </p:cNvPr>
                <p:cNvCxnSpPr/>
                <p:nvPr/>
              </p:nvCxnSpPr>
              <p:spPr>
                <a:xfrm>
                  <a:off x="6709465" y="1057275"/>
                  <a:ext cx="2028825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2E64BFE-EA9F-0E43-B851-39708543E413}"/>
                </a:ext>
              </a:extLst>
            </p:cNvPr>
            <p:cNvSpPr txBox="1"/>
            <p:nvPr/>
          </p:nvSpPr>
          <p:spPr>
            <a:xfrm>
              <a:off x="13022" y="5771513"/>
              <a:ext cx="2702406" cy="407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.5A Uncropped data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0223E56-1693-EC4D-88B6-41486EDF3D6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flipH="1">
              <a:off x="1901923" y="2524804"/>
              <a:ext cx="7030871" cy="170573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457711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C3B6D453-6459-594B-9F7A-40DD15D67FEA}"/>
              </a:ext>
            </a:extLst>
          </p:cNvPr>
          <p:cNvSpPr txBox="1"/>
          <p:nvPr/>
        </p:nvSpPr>
        <p:spPr>
          <a:xfrm>
            <a:off x="302582" y="6325215"/>
            <a:ext cx="2702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.5A Uncropped data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FE6F309-B716-7543-867B-F53C2D3D6411}"/>
              </a:ext>
            </a:extLst>
          </p:cNvPr>
          <p:cNvGrpSpPr/>
          <p:nvPr/>
        </p:nvGrpSpPr>
        <p:grpSpPr>
          <a:xfrm>
            <a:off x="633721" y="1211905"/>
            <a:ext cx="11325685" cy="2727110"/>
            <a:chOff x="1290946" y="1311917"/>
            <a:chExt cx="10706672" cy="2727110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785D6BFD-0D79-964D-8555-13EAA106EF22}"/>
                </a:ext>
              </a:extLst>
            </p:cNvPr>
            <p:cNvGrpSpPr/>
            <p:nvPr/>
          </p:nvGrpSpPr>
          <p:grpSpPr>
            <a:xfrm>
              <a:off x="1290946" y="1311917"/>
              <a:ext cx="10706672" cy="2727110"/>
              <a:chOff x="385486" y="-346704"/>
              <a:chExt cx="11635473" cy="3116677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D3963D90-AEF3-8F42-AF77-CE7D82D588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bright="53000"/>
                        </a14:imgEffect>
                      </a14:imgLayer>
                    </a14:imgProps>
                  </a:ext>
                </a:extLst>
              </a:blip>
              <a:srcRect l="12586" t="33154" r="6421" b="25814"/>
              <a:stretch/>
            </p:blipFill>
            <p:spPr>
              <a:xfrm flipH="1">
                <a:off x="951035" y="-346704"/>
                <a:ext cx="10458420" cy="3116677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DEBABF1-AC99-C44D-BC67-A5647F2FDD1B}"/>
                  </a:ext>
                </a:extLst>
              </p:cNvPr>
              <p:cNvSpPr txBox="1"/>
              <p:nvPr/>
            </p:nvSpPr>
            <p:spPr>
              <a:xfrm>
                <a:off x="10974881" y="842302"/>
                <a:ext cx="1046078" cy="4220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0D981C63-539C-9B40-B23F-6EFA260306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1255" y="1190978"/>
                <a:ext cx="585787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5595EC03-19ED-2E49-9811-37BEDCCEDC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1255" y="779137"/>
                <a:ext cx="585787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B403CB4A-FFD9-2A44-A614-42C68B0132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1255" y="1786291"/>
                <a:ext cx="585787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1DA6E7E-B3CB-144F-A3A7-74502F90C6F1}"/>
                  </a:ext>
                </a:extLst>
              </p:cNvPr>
              <p:cNvSpPr txBox="1"/>
              <p:nvPr/>
            </p:nvSpPr>
            <p:spPr>
              <a:xfrm>
                <a:off x="406917" y="555552"/>
                <a:ext cx="453213" cy="4220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0208583-2C3E-B242-A99B-E30A1DA041B0}"/>
                  </a:ext>
                </a:extLst>
              </p:cNvPr>
              <p:cNvSpPr txBox="1"/>
              <p:nvPr/>
            </p:nvSpPr>
            <p:spPr>
              <a:xfrm>
                <a:off x="406917" y="959113"/>
                <a:ext cx="453213" cy="4220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96B16A7-8CC2-6E44-B6C8-B9A7F82B62B9}"/>
                  </a:ext>
                </a:extLst>
              </p:cNvPr>
              <p:cNvSpPr txBox="1"/>
              <p:nvPr/>
            </p:nvSpPr>
            <p:spPr>
              <a:xfrm>
                <a:off x="385486" y="1573463"/>
                <a:ext cx="457200" cy="4220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B4B7E81-01AA-9B48-8460-6E77FD5B4620}"/>
                </a:ext>
              </a:extLst>
            </p:cNvPr>
            <p:cNvSpPr txBox="1"/>
            <p:nvPr/>
          </p:nvSpPr>
          <p:spPr>
            <a:xfrm>
              <a:off x="3475179" y="1326203"/>
              <a:ext cx="6519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AL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E8D04DE-12C3-FF48-9A86-BE9B13C7589B}"/>
                </a:ext>
              </a:extLst>
            </p:cNvPr>
            <p:cNvSpPr txBox="1"/>
            <p:nvPr/>
          </p:nvSpPr>
          <p:spPr>
            <a:xfrm>
              <a:off x="8784963" y="1326203"/>
              <a:ext cx="1314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E-Cig-2.4%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D949A2D-B534-8847-9E54-A8040D7B7F60}"/>
                </a:ext>
              </a:extLst>
            </p:cNvPr>
            <p:cNvSpPr txBox="1"/>
            <p:nvPr/>
          </p:nvSpPr>
          <p:spPr>
            <a:xfrm>
              <a:off x="6210014" y="1326203"/>
              <a:ext cx="12823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E-Cig-0%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1B04F597-DC82-F540-B1B3-22CA1089EC0A}"/>
                </a:ext>
              </a:extLst>
            </p:cNvPr>
            <p:cNvCxnSpPr/>
            <p:nvPr/>
          </p:nvCxnSpPr>
          <p:spPr>
            <a:xfrm>
              <a:off x="2884095" y="1682414"/>
              <a:ext cx="1859602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AB1A3C5B-9B83-0C4A-99F6-545A5F38C9F7}"/>
                </a:ext>
              </a:extLst>
            </p:cNvPr>
            <p:cNvCxnSpPr/>
            <p:nvPr/>
          </p:nvCxnSpPr>
          <p:spPr>
            <a:xfrm>
              <a:off x="5921368" y="1682414"/>
              <a:ext cx="1859602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60B6C2A5-E742-BB47-8413-DE421188C4E0}"/>
                </a:ext>
              </a:extLst>
            </p:cNvPr>
            <p:cNvCxnSpPr/>
            <p:nvPr/>
          </p:nvCxnSpPr>
          <p:spPr>
            <a:xfrm>
              <a:off x="8477945" y="1682414"/>
              <a:ext cx="1859602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6128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</TotalTime>
  <Words>90</Words>
  <Application>Microsoft Macintosh PowerPoint</Application>
  <PresentationFormat>Widescreen</PresentationFormat>
  <Paragraphs>5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rul Hasan</dc:creator>
  <cp:lastModifiedBy>Kamrul Hasan</cp:lastModifiedBy>
  <cp:revision>18</cp:revision>
  <dcterms:created xsi:type="dcterms:W3CDTF">2020-07-02T07:51:32Z</dcterms:created>
  <dcterms:modified xsi:type="dcterms:W3CDTF">2020-09-18T01:31:07Z</dcterms:modified>
</cp:coreProperties>
</file>